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965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6A34C5-6CD8-47C8-83B9-0A446752BC6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B2646E-0612-4436-9AF9-C81710F70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59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97DC217-DF71-1A49-B3EA-559F1F43B0FF}" type="slidenum">
              <a:rPr lang="en-US" altLang="ja-JP" smtClean="0"/>
              <a:pPr/>
              <a:t>1</a:t>
            </a:fld>
            <a:endParaRPr lang="en-US" altLang="en-US" dirty="0">
              <a:ea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0526949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36E9F4-5A7E-8CD0-3E75-001557EC53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C29C380-4C32-73F4-EC9C-BBEA56C6D9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59CA27-53F7-4094-E37A-2A1E1F9C0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C232FB-3ECD-4280-FEF9-489DC5D8E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079D75-C73E-F601-632B-DCD2E0D14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9789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FD87B3-8FAF-E881-2866-923D7570D7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5A3CD2A-657F-98E1-9679-D01066294B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8072B2-F936-4D5E-FC1C-61719FCE0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D66E19-691B-C6CC-54BA-FEC645A2A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85D7D7-1B48-8ED9-32D1-FA1B47028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829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4B811DA-DD1C-7305-F87A-EB18700341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87F240-06CE-E9C9-E237-CCFCD0F636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FF3253-DD83-7209-51D2-7A0CFCEF86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D27234-7746-CE90-D29D-986F5B19B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A0AEFE-7AE4-8480-F7DF-5E2B45B9D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041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2821B9-8A21-4094-5DD6-72188F062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93D1229-3CC0-E315-DFD2-B7AE8698D6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78826C-2EE7-A3B4-2CCD-07065B628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AD2D0D-07F5-37FA-2266-A9A625577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D606F3-3AD6-CF20-CE2D-FDB5747A9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471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5DE6A6-E58F-9ED7-DFE6-79318109A8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6E6E6F-DE12-74FC-57B1-15931580F5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7BAF3E-8529-5B7B-6F7F-377BD4166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A548CE-A3B2-D20C-910A-A8BACCC39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047E6C-9476-F8BC-C924-CDF393CB7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713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DDCB25-B2B3-9068-143B-A35A37F2B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6182AE1-0049-FCBB-9963-9A68F0BD32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045FB1F-88B6-19F4-0C87-48E52E642B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B6E781-FC67-0FE0-A5C8-DF0D5531C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2009946-F1F6-7326-3ACF-0F239F4A0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70EAA7-D2B0-E1CD-EC8D-1516136A6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863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662FBB-253A-FDAE-1F95-23C91B6F8B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B7F8A3A-39E9-A86E-E2C4-0EC2AFE5B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59B7F32-C5D6-79CF-F40D-02D275D5CB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ED157F7-4C41-DF5A-216A-6FD454A18D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DF5DBF1-5EB5-0EED-30C8-6BBEBCE8A2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B9626A4-6E4F-B28C-6AD5-B637709A2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C0AAF8B-98A9-163C-8BE1-FAEBBFAB2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8C6FDBB-872B-B0DF-7766-91F5549EC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339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96DB24-F9A2-EA8F-BA24-0EA22FEF71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1ED43F4-85EC-1F61-17E7-778EAAB15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3DC3CAD-1384-BB18-0B2F-E121FE6245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24DC85B-1A0C-7A4F-A67B-4371EAAD9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5193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7EF5D3E-49D4-0582-232F-77AA8018C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DE77E2C-6460-C076-A573-BDCD8D602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0F848DE-08C0-56F9-2669-48606E642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222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96282E-0C5E-03F3-9B2F-A5F2C3870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03F92D-6821-7896-95DA-EFF79E03D9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0FB8340-5DF4-6A3D-F0DC-8AE3A3A9F3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8D6D7CC-F567-4204-0280-0D768443F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8AE231-B015-73FF-FCA3-526C3287D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1CD202-C7F0-9605-6715-FAB4F5264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096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2B39BC-DA09-E693-B8E4-6928C3D427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4EA0028-81A4-E642-2F92-91C8D1716D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AD6EA31-6272-8577-BC6D-F214D91936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373BEA8-5AA9-C371-815C-34E6CCE4C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6B3AD79-873B-1B36-D8F7-8F796A4CA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0FE4B0-B072-178B-AC69-C0A5A2933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4684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194621E-2BC4-C85B-8708-A153149D9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E0B7986-28D3-10C7-1D18-1AEE698464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55E6AC-124D-05B7-6BC2-DE4AE9631A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78E85F-5205-445B-918E-7C15BDC9E3C4}" type="datetimeFigureOut">
              <a:rPr kumimoji="1" lang="ja-JP" altLang="en-US" smtClean="0"/>
              <a:t>2025/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EBB557F-6D3D-30F2-6AC6-B501C71CDE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3A7843-41EC-CAE2-3509-ACC8040FCA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071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4A3360F8-A97D-0F49-D703-9B3EA4BDFCAA}"/>
              </a:ext>
            </a:extLst>
          </p:cNvPr>
          <p:cNvSpPr/>
          <p:nvPr/>
        </p:nvSpPr>
        <p:spPr>
          <a:xfrm>
            <a:off x="716972" y="259775"/>
            <a:ext cx="8603672" cy="5307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ll children who underwent strabismus surgery		n = 3,571</a:t>
            </a:r>
            <a:endParaRPr kumimoji="1" lang="ja-JP" altLang="en-US" sz="22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6D1DF735-DCA7-BD02-44BE-BAAA06AEDD0C}"/>
              </a:ext>
            </a:extLst>
          </p:cNvPr>
          <p:cNvSpPr/>
          <p:nvPr/>
        </p:nvSpPr>
        <p:spPr>
          <a:xfrm>
            <a:off x="716972" y="3125441"/>
            <a:ext cx="8603672" cy="5457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ligible in the analysis					</a:t>
            </a:r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 = 2,772</a:t>
            </a: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AC591836-495E-83D5-25A8-D207DD09AA2C}"/>
              </a:ext>
            </a:extLst>
          </p:cNvPr>
          <p:cNvSpPr/>
          <p:nvPr/>
        </p:nvSpPr>
        <p:spPr>
          <a:xfrm>
            <a:off x="2171697" y="942308"/>
            <a:ext cx="8977747" cy="20435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xcluded	n = 799 </a:t>
            </a:r>
          </a:p>
          <a:p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		Under 3 years old and over 16 years old		n = 380</a:t>
            </a:r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		Second and subsequent strabismus surgery	</a:t>
            </a:r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 = 352</a:t>
            </a:r>
          </a:p>
          <a:p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		Gene</a:t>
            </a:r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bnormality				n =   46</a:t>
            </a:r>
          </a:p>
          <a:p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		ASA-PS Ⅲ, Ⅳ, Ⅴ</a:t>
            </a:r>
            <a:r>
              <a:rPr kumimoji="1" lang="ja-JP" alt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				n</a:t>
            </a:r>
            <a:r>
              <a:rPr kumimoji="1" lang="ja-JP" alt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=</a:t>
            </a:r>
            <a:r>
              <a:rPr kumimoji="1" lang="ja-JP" alt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  </a:t>
            </a:r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4</a:t>
            </a:r>
          </a:p>
          <a:p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		Desflurane</a:t>
            </a:r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dministration			n</a:t>
            </a:r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=     7</a:t>
            </a: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88DB965A-A013-4DB7-7340-04E6866738F4}"/>
              </a:ext>
            </a:extLst>
          </p:cNvPr>
          <p:cNvCxnSpPr>
            <a:cxnSpLocks/>
          </p:cNvCxnSpPr>
          <p:nvPr/>
        </p:nvCxnSpPr>
        <p:spPr>
          <a:xfrm>
            <a:off x="1445007" y="790548"/>
            <a:ext cx="0" cy="2334893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3950249B-2A53-2A61-6E06-08BEF1DB9598}"/>
              </a:ext>
            </a:extLst>
          </p:cNvPr>
          <p:cNvCxnSpPr>
            <a:cxnSpLocks/>
            <a:endCxn id="8" idx="1"/>
          </p:cNvCxnSpPr>
          <p:nvPr/>
        </p:nvCxnSpPr>
        <p:spPr>
          <a:xfrm>
            <a:off x="1423888" y="1964080"/>
            <a:ext cx="747809" cy="0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D6BE70C0-8CAA-D9A3-BF73-E4898FD1C315}"/>
              </a:ext>
            </a:extLst>
          </p:cNvPr>
          <p:cNvCxnSpPr>
            <a:cxnSpLocks/>
          </p:cNvCxnSpPr>
          <p:nvPr/>
        </p:nvCxnSpPr>
        <p:spPr>
          <a:xfrm>
            <a:off x="1423888" y="3671225"/>
            <a:ext cx="0" cy="784985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9FFC08AC-DEA7-C9B7-9FF1-3B1177A4E28A}"/>
              </a:ext>
            </a:extLst>
          </p:cNvPr>
          <p:cNvCxnSpPr>
            <a:cxnSpLocks/>
            <a:endCxn id="19" idx="1"/>
          </p:cNvCxnSpPr>
          <p:nvPr/>
        </p:nvCxnSpPr>
        <p:spPr>
          <a:xfrm>
            <a:off x="1445007" y="4063718"/>
            <a:ext cx="728036" cy="0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6C995AB3-30D7-A202-6306-3F58ED84ABFF}"/>
              </a:ext>
            </a:extLst>
          </p:cNvPr>
          <p:cNvSpPr/>
          <p:nvPr/>
        </p:nvSpPr>
        <p:spPr>
          <a:xfrm>
            <a:off x="2173043" y="3860622"/>
            <a:ext cx="8976401" cy="4061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lang="en-US" altLang="ja-JP" sz="2200" dirty="0" err="1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aesthesia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egimens outside the top 10 regimens		n = 550</a:t>
            </a:r>
            <a:endParaRPr kumimoji="1" lang="en-US" altLang="ja-JP" sz="22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A43559EA-0FF8-6CC4-8748-A3FEE6CF1097}"/>
              </a:ext>
            </a:extLst>
          </p:cNvPr>
          <p:cNvSpPr/>
          <p:nvPr/>
        </p:nvSpPr>
        <p:spPr>
          <a:xfrm>
            <a:off x="716971" y="4456210"/>
            <a:ext cx="8603673" cy="5457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p 10 </a:t>
            </a:r>
            <a:r>
              <a:rPr lang="en-US" altLang="ja-JP" sz="2200" dirty="0" err="1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aesthesia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egimens: eligible in the second analysis	</a:t>
            </a:r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 = 2,222</a:t>
            </a:r>
          </a:p>
        </p:txBody>
      </p: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5C30A3C5-FE2A-6B0A-297F-591E603214B0}"/>
              </a:ext>
            </a:extLst>
          </p:cNvPr>
          <p:cNvCxnSpPr>
            <a:cxnSpLocks/>
          </p:cNvCxnSpPr>
          <p:nvPr/>
        </p:nvCxnSpPr>
        <p:spPr>
          <a:xfrm>
            <a:off x="1445007" y="5001994"/>
            <a:ext cx="0" cy="1102619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78EDFAF8-EB9E-5C70-648D-6DDD0F0EE893}"/>
              </a:ext>
            </a:extLst>
          </p:cNvPr>
          <p:cNvCxnSpPr>
            <a:cxnSpLocks/>
            <a:endCxn id="33" idx="1"/>
          </p:cNvCxnSpPr>
          <p:nvPr/>
        </p:nvCxnSpPr>
        <p:spPr>
          <a:xfrm>
            <a:off x="1445007" y="5557354"/>
            <a:ext cx="728037" cy="0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C16F2F98-BE49-1076-4052-6611CF19CFA1}"/>
              </a:ext>
            </a:extLst>
          </p:cNvPr>
          <p:cNvSpPr/>
          <p:nvPr/>
        </p:nvSpPr>
        <p:spPr>
          <a:xfrm>
            <a:off x="2173044" y="5241195"/>
            <a:ext cx="8976399" cy="63231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ja-JP" altLang="en-US" sz="20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lang="en-US" altLang="ja-JP" sz="20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ther </a:t>
            </a:r>
            <a:r>
              <a:rPr lang="en-US" altLang="ja-JP" sz="2000" dirty="0" err="1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aesthesia</a:t>
            </a:r>
            <a:r>
              <a:rPr lang="en-US" altLang="ja-JP" sz="20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egimens than TIVA with propofol, fentanyl and remifentanil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								n = 592</a:t>
            </a:r>
            <a:endParaRPr kumimoji="1" lang="en-US" altLang="ja-JP" sz="22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840695DF-D69F-0774-86A8-25F95229267B}"/>
              </a:ext>
            </a:extLst>
          </p:cNvPr>
          <p:cNvSpPr/>
          <p:nvPr/>
        </p:nvSpPr>
        <p:spPr>
          <a:xfrm>
            <a:off x="716971" y="6111256"/>
            <a:ext cx="8603673" cy="4869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ja-JP" altLang="en-US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 TIVA regimens: eligible in the primary analysis		</a:t>
            </a:r>
            <a:r>
              <a:rPr kumimoji="1"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 = </a:t>
            </a:r>
            <a:r>
              <a:rPr lang="en-US" altLang="ja-JP" sz="22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,630</a:t>
            </a:r>
            <a:endParaRPr kumimoji="1" lang="en-US" altLang="ja-JP" sz="22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1112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</TotalTime>
  <Words>163</Words>
  <Application>Microsoft Office PowerPoint</Application>
  <PresentationFormat>ワイド画面</PresentationFormat>
  <Paragraphs>1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ichiro Obara</dc:creator>
  <cp:lastModifiedBy>Soichiro Obara</cp:lastModifiedBy>
  <cp:revision>32</cp:revision>
  <dcterms:created xsi:type="dcterms:W3CDTF">2024-12-18T00:08:32Z</dcterms:created>
  <dcterms:modified xsi:type="dcterms:W3CDTF">2025-01-25T04:53:51Z</dcterms:modified>
</cp:coreProperties>
</file>